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73" r:id="rId2"/>
  </p:sldIdLst>
  <p:sldSz cx="6858000" cy="9906000" type="A4"/>
  <p:notesSz cx="7099300" cy="10234613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Ricardo Machado" initials="RM" lastIdx="10" clrIdx="0">
    <p:extLst>
      <p:ext uri="{19B8F6BF-5375-455C-9EA6-DF929625EA0E}">
        <p15:presenceInfo xmlns:p15="http://schemas.microsoft.com/office/powerpoint/2012/main" userId="S-1-5-21-1275210071-1708537768-1343024091-3239" providerId="AD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073A0DAA-6AF3-43AB-8588-CEC1D06C72B9}" styleName="Medium Style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9D7B26C5-4107-4FEC-AEDC-1716B250A1EF}" styleName="Light Style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D7AC3CCA-C797-4891-BE02-D94E43425B78}" styleName="Medium Style 4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dk1"/>
              </a:solidFill>
            </a:ln>
          </a:left>
          <a:right>
            <a:ln w="12700" cmpd="sng">
              <a:solidFill>
                <a:schemeClr val="dk1"/>
              </a:solidFill>
            </a:ln>
          </a:right>
          <a:top>
            <a:ln w="12700" cmpd="sng">
              <a:solidFill>
                <a:schemeClr val="dk1"/>
              </a:solidFill>
            </a:ln>
          </a:top>
          <a:bottom>
            <a:ln w="12700" cmpd="sng">
              <a:solidFill>
                <a:schemeClr val="dk1"/>
              </a:solidFill>
            </a:ln>
          </a:bottom>
          <a:insideH>
            <a:ln w="12700" cmpd="sng">
              <a:solidFill>
                <a:schemeClr val="dk1"/>
              </a:solidFill>
            </a:ln>
          </a:insideH>
          <a:insideV>
            <a:ln w="12700" cmpd="sng">
              <a:solidFill>
                <a:schemeClr val="dk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25400" cmpd="sng">
              <a:solidFill>
                <a:schemeClr val="dk1"/>
              </a:solidFill>
            </a:ln>
          </a:top>
        </a:tcBdr>
        <a:fill>
          <a:solidFill>
            <a:schemeClr val="dk1">
              <a:tint val="20000"/>
            </a:schemeClr>
          </a:solidFill>
        </a:fill>
      </a:tcStyle>
    </a:lastRow>
    <a:firstRow>
      <a:tcTxStyle b="on"/>
      <a:tcStyle>
        <a:tcBdr/>
        <a:fill>
          <a:solidFill>
            <a:schemeClr val="dk1">
              <a:tint val="20000"/>
            </a:schemeClr>
          </a:solidFill>
        </a:fill>
      </a:tcStyle>
    </a:firstRow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1947" autoAdjust="0"/>
    <p:restoredTop sz="94660"/>
  </p:normalViewPr>
  <p:slideViewPr>
    <p:cSldViewPr>
      <p:cViewPr varScale="1">
        <p:scale>
          <a:sx n="74" d="100"/>
          <a:sy n="74" d="100"/>
        </p:scale>
        <p:origin x="2772" y="78"/>
      </p:cViewPr>
      <p:guideLst>
        <p:guide orient="horz" pos="3120"/>
        <p:guide pos="2160"/>
      </p:guideLst>
    </p:cSldViewPr>
  </p:slideViewPr>
  <p:notesTextViewPr>
    <p:cViewPr>
      <p:scale>
        <a:sx n="400" d="100"/>
        <a:sy n="4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76575" cy="512763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4021138" y="0"/>
            <a:ext cx="3076575" cy="512763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956A0A2-FB4C-4DBC-8093-13AB518DD7E7}" type="datetimeFigureOut">
              <a:rPr lang="en-US" smtClean="0"/>
              <a:t>5/2/2016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54263" y="1279525"/>
            <a:ext cx="2390775" cy="34544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09613" y="4926013"/>
            <a:ext cx="5680075" cy="4029075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721850"/>
            <a:ext cx="3076575" cy="51276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4021138" y="9721850"/>
            <a:ext cx="3076575" cy="51276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20B1465-33C8-4385-A0BB-9F8DC05EFD4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5831253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3077282"/>
            <a:ext cx="5829300" cy="2123369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de-DE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de-DE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2FBFE7-9977-4858-BA88-EC8DDE37AD38}" type="datetimeFigureOut">
              <a:rPr lang="de-DE" smtClean="0"/>
              <a:t>02.05.2016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0EC743-6F36-4AB7-8C48-476F812AD9E6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12269369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de-DE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de-DE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2FBFE7-9977-4858-BA88-EC8DDE37AD38}" type="datetimeFigureOut">
              <a:rPr lang="de-DE" smtClean="0"/>
              <a:t>02.05.2016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0EC743-6F36-4AB7-8C48-476F812AD9E6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78730191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573264"/>
            <a:ext cx="1157288" cy="1220822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de-DE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573264"/>
            <a:ext cx="3357563" cy="1220822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de-DE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2FBFE7-9977-4858-BA88-EC8DDE37AD38}" type="datetimeFigureOut">
              <a:rPr lang="de-DE" smtClean="0"/>
              <a:t>02.05.2016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0EC743-6F36-4AB7-8C48-476F812AD9E6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1224094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de-DE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de-DE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2FBFE7-9977-4858-BA88-EC8DDE37AD38}" type="datetimeFigureOut">
              <a:rPr lang="de-DE" smtClean="0"/>
              <a:t>02.05.2016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0EC743-6F36-4AB7-8C48-476F812AD9E6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93127941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6365523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de-DE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4198586"/>
            <a:ext cx="5829300" cy="216693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2FBFE7-9977-4858-BA88-EC8DDE37AD38}" type="datetimeFigureOut">
              <a:rPr lang="de-DE" smtClean="0"/>
              <a:t>02.05.2016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0EC743-6F36-4AB7-8C48-476F812AD9E6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67254225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de-DE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3338690"/>
            <a:ext cx="2257425" cy="944280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de-DE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3338690"/>
            <a:ext cx="2257425" cy="944280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de-DE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2FBFE7-9977-4858-BA88-EC8DDE37AD38}" type="datetimeFigureOut">
              <a:rPr lang="de-DE" smtClean="0"/>
              <a:t>02.05.2016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0EC743-6F36-4AB7-8C48-476F812AD9E6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41724511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de-DE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de-DE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217385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de-DE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2FBFE7-9977-4858-BA88-EC8DDE37AD38}" type="datetimeFigureOut">
              <a:rPr lang="de-DE" smtClean="0"/>
              <a:t>02.05.2016</a:t>
            </a:fld>
            <a:endParaRPr lang="de-DE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0EC743-6F36-4AB7-8C48-476F812AD9E6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89312822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de-DE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2FBFE7-9977-4858-BA88-EC8DDE37AD38}" type="datetimeFigureOut">
              <a:rPr lang="de-DE" smtClean="0"/>
              <a:t>02.05.2016</a:t>
            </a:fld>
            <a:endParaRPr lang="de-DE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0EC743-6F36-4AB7-8C48-476F812AD9E6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24701169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2FBFE7-9977-4858-BA88-EC8DDE37AD38}" type="datetimeFigureOut">
              <a:rPr lang="de-DE" smtClean="0"/>
              <a:t>02.05.2016</a:t>
            </a:fld>
            <a:endParaRPr lang="de-DE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0EC743-6F36-4AB7-8C48-476F812AD9E6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2161387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94405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de-DE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94406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de-DE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2072923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2FBFE7-9977-4858-BA88-EC8DDE37AD38}" type="datetimeFigureOut">
              <a:rPr lang="de-DE" smtClean="0"/>
              <a:t>02.05.2016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0EC743-6F36-4AB7-8C48-476F812AD9E6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14930138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de-DE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2FBFE7-9977-4858-BA88-EC8DDE37AD38}" type="datetimeFigureOut">
              <a:rPr lang="de-DE" smtClean="0"/>
              <a:t>02.05.2016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0EC743-6F36-4AB7-8C48-476F812AD9E6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67352297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de-DE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311401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de-DE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42FBFE7-9977-4858-BA88-EC8DDE37AD38}" type="datetimeFigureOut">
              <a:rPr lang="de-DE" smtClean="0"/>
              <a:t>02.05.2016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9181395"/>
            <a:ext cx="21717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C0EC743-6F36-4AB7-8C48-476F812AD9E6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33595038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3"/>
          <p:cNvGraphicFramePr>
            <a:graphicFrameLocks noGrp="1"/>
          </p:cNvGraphicFramePr>
          <p:nvPr>
            <p:extLst/>
          </p:nvPr>
        </p:nvGraphicFramePr>
        <p:xfrm>
          <a:off x="912757" y="1298154"/>
          <a:ext cx="5184576" cy="5251704"/>
        </p:xfrm>
        <a:graphic>
          <a:graphicData uri="http://schemas.openxmlformats.org/drawingml/2006/table">
            <a:tbl>
              <a:tblPr firstRow="1" firstCol="1" bandRow="1">
                <a:tableStyleId>{D7AC3CCA-C797-4891-BE02-D94E43425B78}</a:tableStyleId>
              </a:tblPr>
              <a:tblGrid>
                <a:gridCol w="864096"/>
                <a:gridCol w="648072"/>
                <a:gridCol w="576064"/>
                <a:gridCol w="792088"/>
                <a:gridCol w="1224136"/>
                <a:gridCol w="1080120"/>
              </a:tblGrid>
              <a:tr h="190500">
                <a:tc rowSpan="2"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erbivore</a:t>
                      </a:r>
                      <a:endParaRPr lang="de-CH" sz="10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solidFill>
                      <a:schemeClr val="bg1"/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lot</a:t>
                      </a:r>
                      <a:endParaRPr lang="de-CH" sz="10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solidFill>
                      <a:schemeClr val="bg1"/>
                    </a:solidFill>
                  </a:tcPr>
                </a:tc>
                <a:tc gridSpan="4"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ype of evidence</a:t>
                      </a:r>
                      <a:endParaRPr lang="de-CH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solidFill>
                      <a:schemeClr val="bg1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</a:tr>
              <a:tr h="19050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amage</a:t>
                      </a:r>
                      <a:endParaRPr lang="de-CH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irect observation</a:t>
                      </a:r>
                      <a:endParaRPr lang="de-CH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hotographs by the authors or other scientists </a:t>
                      </a:r>
                      <a:endParaRPr lang="de-CH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ther traces (excrements, eggs, burrows)</a:t>
                      </a:r>
                      <a:endParaRPr lang="de-CH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solidFill>
                      <a:schemeClr val="bg1"/>
                    </a:solidFill>
                  </a:tcPr>
                </a:tc>
              </a:tr>
              <a:tr h="190500">
                <a:tc rowSpan="3"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eer</a:t>
                      </a:r>
                      <a:endParaRPr lang="de-CH" sz="10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ytle</a:t>
                      </a:r>
                      <a:endParaRPr lang="de-CH" sz="10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X</a:t>
                      </a:r>
                      <a:endParaRPr lang="de-CH" sz="10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CH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X</a:t>
                      </a:r>
                      <a:endParaRPr lang="de-CH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CH" sz="1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X</a:t>
                      </a:r>
                      <a:endParaRPr lang="de-CH" sz="10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CH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X</a:t>
                      </a:r>
                      <a:endParaRPr lang="de-CH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solidFill>
                      <a:schemeClr val="bg1"/>
                    </a:solidFill>
                  </a:tcPr>
                </a:tc>
              </a:tr>
              <a:tr h="19050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CH" sz="1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now</a:t>
                      </a:r>
                      <a:endParaRPr lang="de-CH" sz="10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CH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</a:t>
                      </a:r>
                      <a:endParaRPr lang="de-CH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CH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</a:t>
                      </a:r>
                      <a:endParaRPr lang="de-CH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CH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</a:t>
                      </a:r>
                      <a:endParaRPr lang="de-CH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CH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</a:t>
                      </a:r>
                      <a:endParaRPr lang="de-CH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solidFill>
                      <a:schemeClr val="bg1"/>
                    </a:solidFill>
                  </a:tcPr>
                </a:tc>
              </a:tr>
              <a:tr h="19050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CH" sz="1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oplar</a:t>
                      </a:r>
                      <a:endParaRPr lang="de-CH" sz="10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CH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</a:t>
                      </a:r>
                      <a:endParaRPr lang="de-CH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CH" sz="1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</a:t>
                      </a:r>
                      <a:endParaRPr lang="de-CH" sz="10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CH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</a:t>
                      </a:r>
                      <a:endParaRPr lang="de-CH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CH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</a:t>
                      </a:r>
                      <a:endParaRPr lang="de-CH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solidFill>
                      <a:schemeClr val="bg1"/>
                    </a:solidFill>
                  </a:tcPr>
                </a:tc>
              </a:tr>
              <a:tr h="190500">
                <a:tc rowSpan="3"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CH" sz="1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abbits</a:t>
                      </a:r>
                      <a:endParaRPr lang="de-CH" sz="10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CH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ytle</a:t>
                      </a:r>
                      <a:endParaRPr lang="de-CH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CH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X</a:t>
                      </a:r>
                      <a:endParaRPr lang="de-CH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CH" sz="1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X</a:t>
                      </a:r>
                      <a:endParaRPr lang="de-CH" sz="10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CH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X</a:t>
                      </a:r>
                      <a:endParaRPr lang="de-CH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CH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</a:t>
                      </a:r>
                      <a:endParaRPr lang="de-CH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solidFill>
                      <a:schemeClr val="bg1"/>
                    </a:solidFill>
                  </a:tcPr>
                </a:tc>
              </a:tr>
              <a:tr h="19050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CH" sz="1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now</a:t>
                      </a:r>
                      <a:endParaRPr lang="de-CH" sz="10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CH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</a:t>
                      </a:r>
                      <a:endParaRPr lang="de-CH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CH" sz="1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</a:t>
                      </a:r>
                      <a:endParaRPr lang="de-CH" sz="10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CH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</a:t>
                      </a:r>
                      <a:endParaRPr lang="de-CH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CH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</a:t>
                      </a:r>
                      <a:endParaRPr lang="de-CH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solidFill>
                      <a:schemeClr val="bg1"/>
                    </a:solidFill>
                  </a:tcPr>
                </a:tc>
              </a:tr>
              <a:tr h="19050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CH" sz="1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oplar</a:t>
                      </a:r>
                      <a:endParaRPr lang="de-CH" sz="10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CH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</a:t>
                      </a:r>
                      <a:endParaRPr lang="de-CH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CH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</a:t>
                      </a:r>
                      <a:endParaRPr lang="de-CH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CH" sz="1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</a:t>
                      </a:r>
                      <a:endParaRPr lang="de-CH" sz="10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CH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</a:t>
                      </a:r>
                      <a:endParaRPr lang="de-CH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solidFill>
                      <a:schemeClr val="bg1"/>
                    </a:solidFill>
                  </a:tcPr>
                </a:tc>
              </a:tr>
              <a:tr h="190500">
                <a:tc rowSpan="3"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CH" sz="1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Wood rats</a:t>
                      </a:r>
                      <a:endParaRPr lang="de-CH" sz="10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CH" sz="1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ytle</a:t>
                      </a:r>
                      <a:endParaRPr lang="de-CH" sz="10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CH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X</a:t>
                      </a:r>
                      <a:endParaRPr lang="de-CH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CH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</a:t>
                      </a:r>
                      <a:endParaRPr lang="de-CH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CH" sz="1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</a:t>
                      </a:r>
                      <a:endParaRPr lang="de-CH" sz="10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CH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</a:t>
                      </a:r>
                      <a:endParaRPr lang="de-CH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solidFill>
                      <a:schemeClr val="bg1"/>
                    </a:solidFill>
                  </a:tcPr>
                </a:tc>
              </a:tr>
              <a:tr h="19050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CH" sz="1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now</a:t>
                      </a:r>
                      <a:endParaRPr lang="de-CH" sz="10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CH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</a:t>
                      </a:r>
                      <a:endParaRPr lang="de-CH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CH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</a:t>
                      </a:r>
                      <a:endParaRPr lang="de-CH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CH" sz="1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</a:t>
                      </a:r>
                      <a:endParaRPr lang="de-CH" sz="10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CH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</a:t>
                      </a:r>
                      <a:endParaRPr lang="de-CH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solidFill>
                      <a:schemeClr val="bg1"/>
                    </a:solidFill>
                  </a:tcPr>
                </a:tc>
              </a:tr>
              <a:tr h="19050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CH" sz="1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oplar</a:t>
                      </a:r>
                      <a:endParaRPr lang="de-CH" sz="10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CH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</a:t>
                      </a:r>
                      <a:endParaRPr lang="de-CH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CH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</a:t>
                      </a:r>
                      <a:endParaRPr lang="de-CH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CH" sz="1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</a:t>
                      </a:r>
                      <a:endParaRPr lang="de-CH" sz="10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CH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</a:t>
                      </a:r>
                      <a:endParaRPr lang="de-CH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solidFill>
                      <a:schemeClr val="bg1"/>
                    </a:solidFill>
                  </a:tcPr>
                </a:tc>
              </a:tr>
              <a:tr h="190500">
                <a:tc rowSpan="3"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CH" sz="1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ophers</a:t>
                      </a:r>
                      <a:endParaRPr lang="de-CH" sz="10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CH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ytle</a:t>
                      </a:r>
                      <a:endParaRPr lang="de-CH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CH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</a:t>
                      </a:r>
                      <a:endParaRPr lang="de-CH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CH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</a:t>
                      </a:r>
                      <a:endParaRPr lang="de-CH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CH" sz="1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</a:t>
                      </a:r>
                      <a:endParaRPr lang="de-CH" sz="10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CH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</a:t>
                      </a:r>
                      <a:endParaRPr lang="de-CH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solidFill>
                      <a:schemeClr val="bg1"/>
                    </a:solidFill>
                  </a:tcPr>
                </a:tc>
              </a:tr>
              <a:tr h="19050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CH" sz="1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now</a:t>
                      </a:r>
                      <a:endParaRPr lang="de-CH" sz="10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CH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X</a:t>
                      </a:r>
                      <a:endParaRPr lang="de-CH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CH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X</a:t>
                      </a:r>
                      <a:endParaRPr lang="de-CH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CH" sz="1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X</a:t>
                      </a:r>
                      <a:endParaRPr lang="de-CH" sz="10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CH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X</a:t>
                      </a:r>
                      <a:endParaRPr lang="de-CH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solidFill>
                      <a:schemeClr val="bg1"/>
                    </a:solidFill>
                  </a:tcPr>
                </a:tc>
              </a:tr>
              <a:tr h="19050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CH" sz="1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oplar</a:t>
                      </a:r>
                      <a:endParaRPr lang="de-CH" sz="10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CH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</a:t>
                      </a:r>
                      <a:endParaRPr lang="de-CH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CH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</a:t>
                      </a:r>
                      <a:endParaRPr lang="de-CH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CH" sz="1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</a:t>
                      </a:r>
                      <a:endParaRPr lang="de-CH" sz="10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CH" sz="1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</a:t>
                      </a:r>
                      <a:endParaRPr lang="de-CH" sz="10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solidFill>
                      <a:schemeClr val="bg1"/>
                    </a:solidFill>
                  </a:tcPr>
                </a:tc>
              </a:tr>
              <a:tr h="190500">
                <a:tc rowSpan="3"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CH" sz="1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aterpillars</a:t>
                      </a:r>
                      <a:endParaRPr lang="de-CH" sz="10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CH" sz="1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ytle</a:t>
                      </a:r>
                      <a:endParaRPr lang="de-CH" sz="10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CH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X</a:t>
                      </a:r>
                      <a:endParaRPr lang="de-CH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CH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</a:t>
                      </a:r>
                      <a:endParaRPr lang="de-CH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CH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</a:t>
                      </a:r>
                      <a:endParaRPr lang="de-CH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CH" sz="1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X</a:t>
                      </a:r>
                      <a:endParaRPr lang="de-CH" sz="10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solidFill>
                      <a:schemeClr val="bg1"/>
                    </a:solidFill>
                  </a:tcPr>
                </a:tc>
              </a:tr>
              <a:tr h="19050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CH" sz="1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now</a:t>
                      </a:r>
                      <a:endParaRPr lang="de-CH" sz="10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CH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X</a:t>
                      </a:r>
                      <a:endParaRPr lang="de-CH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CH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X</a:t>
                      </a:r>
                      <a:endParaRPr lang="de-CH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CH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X</a:t>
                      </a:r>
                      <a:endParaRPr lang="de-CH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CH" sz="1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X</a:t>
                      </a:r>
                      <a:endParaRPr lang="de-CH" sz="10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solidFill>
                      <a:schemeClr val="bg1"/>
                    </a:solidFill>
                  </a:tcPr>
                </a:tc>
              </a:tr>
              <a:tr h="19050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CH" sz="1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oplar</a:t>
                      </a:r>
                      <a:endParaRPr lang="de-CH" sz="10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CH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X</a:t>
                      </a:r>
                      <a:endParaRPr lang="de-CH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CH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</a:t>
                      </a:r>
                      <a:endParaRPr lang="de-CH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CH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</a:t>
                      </a:r>
                      <a:endParaRPr lang="de-CH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CH" sz="1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X</a:t>
                      </a:r>
                      <a:endParaRPr lang="de-CH" sz="10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solidFill>
                      <a:schemeClr val="bg1"/>
                    </a:solidFill>
                  </a:tcPr>
                </a:tc>
              </a:tr>
              <a:tr h="190500">
                <a:tc rowSpan="3"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CH" sz="1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nts</a:t>
                      </a:r>
                      <a:endParaRPr lang="de-CH" sz="10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CH" sz="1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ytle</a:t>
                      </a:r>
                      <a:endParaRPr lang="de-CH" sz="10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CH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</a:t>
                      </a:r>
                      <a:endParaRPr lang="de-CH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CH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</a:t>
                      </a:r>
                      <a:endParaRPr lang="de-CH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CH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</a:t>
                      </a:r>
                      <a:endParaRPr lang="de-CH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CH" sz="1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</a:t>
                      </a:r>
                      <a:endParaRPr lang="de-CH" sz="10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solidFill>
                      <a:schemeClr val="bg1"/>
                    </a:solidFill>
                  </a:tcPr>
                </a:tc>
              </a:tr>
              <a:tr h="19050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CH" sz="1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now</a:t>
                      </a:r>
                      <a:endParaRPr lang="de-CH" sz="10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CH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X</a:t>
                      </a:r>
                      <a:endParaRPr lang="de-CH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CH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X</a:t>
                      </a:r>
                      <a:endParaRPr lang="de-CH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CH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X</a:t>
                      </a:r>
                      <a:endParaRPr lang="de-CH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CH" sz="1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X</a:t>
                      </a:r>
                      <a:endParaRPr lang="de-CH" sz="10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solidFill>
                      <a:schemeClr val="bg1"/>
                    </a:solidFill>
                  </a:tcPr>
                </a:tc>
              </a:tr>
              <a:tr h="19050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CH" sz="1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oplar</a:t>
                      </a:r>
                      <a:endParaRPr lang="de-CH" sz="10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CH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</a:t>
                      </a:r>
                      <a:endParaRPr lang="de-CH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CH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</a:t>
                      </a:r>
                      <a:endParaRPr lang="de-CH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CH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</a:t>
                      </a:r>
                      <a:endParaRPr lang="de-CH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CH" sz="1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</a:t>
                      </a:r>
                      <a:endParaRPr lang="de-CH" sz="10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solidFill>
                      <a:schemeClr val="bg1"/>
                    </a:solidFill>
                  </a:tcPr>
                </a:tc>
              </a:tr>
              <a:tr h="190500">
                <a:tc rowSpan="3"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CH" sz="1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irids</a:t>
                      </a:r>
                      <a:endParaRPr lang="de-CH" sz="10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CH" sz="1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ytle</a:t>
                      </a:r>
                      <a:endParaRPr lang="de-CH" sz="10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CH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X</a:t>
                      </a:r>
                      <a:endParaRPr lang="de-CH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CH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X</a:t>
                      </a:r>
                      <a:endParaRPr lang="de-CH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CH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</a:t>
                      </a:r>
                      <a:endParaRPr lang="de-CH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CH" sz="1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X</a:t>
                      </a:r>
                      <a:endParaRPr lang="de-CH" sz="10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solidFill>
                      <a:schemeClr val="bg1"/>
                    </a:solidFill>
                  </a:tcPr>
                </a:tc>
              </a:tr>
              <a:tr h="19050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CH" sz="1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now</a:t>
                      </a:r>
                      <a:endParaRPr lang="de-CH" sz="10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CH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X</a:t>
                      </a:r>
                      <a:endParaRPr lang="de-CH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CH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X</a:t>
                      </a:r>
                      <a:endParaRPr lang="de-CH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CH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X</a:t>
                      </a:r>
                      <a:endParaRPr lang="de-CH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CH" sz="1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X</a:t>
                      </a:r>
                      <a:endParaRPr lang="de-CH" sz="10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solidFill>
                      <a:schemeClr val="bg1"/>
                    </a:solidFill>
                  </a:tcPr>
                </a:tc>
              </a:tr>
              <a:tr h="19050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CH" sz="1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oplar</a:t>
                      </a:r>
                      <a:endParaRPr lang="de-CH" sz="10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CH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X</a:t>
                      </a:r>
                      <a:endParaRPr lang="de-CH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CH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X</a:t>
                      </a:r>
                      <a:endParaRPr lang="de-CH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CH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</a:t>
                      </a:r>
                      <a:endParaRPr lang="de-CH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CH" sz="1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X</a:t>
                      </a:r>
                      <a:endParaRPr lang="de-CH" sz="10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solidFill>
                      <a:schemeClr val="bg1"/>
                    </a:solidFill>
                  </a:tcPr>
                </a:tc>
              </a:tr>
              <a:tr h="190500">
                <a:tc rowSpan="3"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CH" sz="1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eafhopers</a:t>
                      </a:r>
                      <a:endParaRPr lang="de-CH" sz="10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CH" sz="1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ytle</a:t>
                      </a:r>
                      <a:endParaRPr lang="de-CH" sz="10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CH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X</a:t>
                      </a:r>
                      <a:endParaRPr lang="de-CH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CH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X</a:t>
                      </a:r>
                      <a:endParaRPr lang="de-CH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CH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</a:t>
                      </a:r>
                      <a:endParaRPr lang="de-CH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CH" sz="1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X</a:t>
                      </a:r>
                      <a:endParaRPr lang="de-CH" sz="10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solidFill>
                      <a:schemeClr val="bg1"/>
                    </a:solidFill>
                  </a:tcPr>
                </a:tc>
              </a:tr>
              <a:tr h="19050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CH" sz="1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now</a:t>
                      </a:r>
                      <a:endParaRPr lang="de-CH" sz="10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CH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X</a:t>
                      </a:r>
                      <a:endParaRPr lang="de-CH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CH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X</a:t>
                      </a:r>
                      <a:endParaRPr lang="de-CH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CH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X</a:t>
                      </a:r>
                      <a:endParaRPr lang="de-CH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CH" sz="1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X</a:t>
                      </a:r>
                      <a:endParaRPr lang="de-CH" sz="10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solidFill>
                      <a:schemeClr val="bg1"/>
                    </a:solidFill>
                  </a:tcPr>
                </a:tc>
              </a:tr>
              <a:tr h="19050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CH" sz="1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oplar</a:t>
                      </a:r>
                      <a:endParaRPr lang="de-CH" sz="10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CH" sz="1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X</a:t>
                      </a:r>
                      <a:endParaRPr lang="de-CH" sz="10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CH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X</a:t>
                      </a:r>
                      <a:endParaRPr lang="de-CH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CH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</a:t>
                      </a:r>
                      <a:endParaRPr lang="de-CH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CH" sz="1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X</a:t>
                      </a:r>
                      <a:endParaRPr lang="de-CH" sz="10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solidFill>
                      <a:schemeClr val="bg1"/>
                    </a:solidFill>
                  </a:tcPr>
                </a:tc>
              </a:tr>
            </a:tbl>
          </a:graphicData>
        </a:graphic>
      </p:graphicFrame>
      <p:sp>
        <p:nvSpPr>
          <p:cNvPr id="9" name="TextBox 8"/>
          <p:cNvSpPr txBox="1"/>
          <p:nvPr/>
        </p:nvSpPr>
        <p:spPr>
          <a:xfrm>
            <a:off x="832675" y="408945"/>
            <a:ext cx="525035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>
                <a:latin typeface="Times New Roman" panose="02020603050405020304" pitchFamily="18" charset="0"/>
                <a:ea typeface="Tahoma" panose="020B0604030504040204" pitchFamily="34" charset="0"/>
                <a:cs typeface="Times New Roman" panose="02020603050405020304" pitchFamily="18" charset="0"/>
              </a:rPr>
              <a:t>Figure </a:t>
            </a:r>
            <a:r>
              <a:rPr lang="en-US" sz="1200" b="1" dirty="0" smtClean="0">
                <a:latin typeface="Times New Roman" panose="02020603050405020304" pitchFamily="18" charset="0"/>
                <a:ea typeface="Tahoma" panose="020B0604030504040204" pitchFamily="34" charset="0"/>
                <a:cs typeface="Times New Roman" panose="02020603050405020304" pitchFamily="18" charset="0"/>
              </a:rPr>
              <a:t>1-source </a:t>
            </a:r>
            <a:r>
              <a:rPr lang="en-US" sz="1200" b="1" smtClean="0">
                <a:latin typeface="Times New Roman" panose="02020603050405020304" pitchFamily="18" charset="0"/>
                <a:ea typeface="Tahoma" panose="020B0604030504040204" pitchFamily="34" charset="0"/>
                <a:cs typeface="Times New Roman" panose="02020603050405020304" pitchFamily="18" charset="0"/>
              </a:rPr>
              <a:t>data </a:t>
            </a:r>
            <a:r>
              <a:rPr lang="en-US" sz="1200" b="1" smtClean="0">
                <a:latin typeface="Times New Roman" panose="02020603050405020304" pitchFamily="18" charset="0"/>
                <a:ea typeface="Tahoma" panose="020B0604030504040204" pitchFamily="34" charset="0"/>
                <a:cs typeface="Times New Roman" panose="02020603050405020304" pitchFamily="18" charset="0"/>
              </a:rPr>
              <a:t>2 </a:t>
            </a:r>
            <a:endParaRPr lang="de-DE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" name="Rectangle 14"/>
          <p:cNvSpPr/>
          <p:nvPr/>
        </p:nvSpPr>
        <p:spPr>
          <a:xfrm>
            <a:off x="836712" y="704528"/>
            <a:ext cx="5380844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de-DE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arameters </a:t>
            </a:r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used to determine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bundance of herbivores (presence/absence) in the three experimental populations </a:t>
            </a:r>
          </a:p>
        </p:txBody>
      </p:sp>
    </p:spTree>
    <p:extLst>
      <p:ext uri="{BB962C8B-B14F-4D97-AF65-F5344CB8AC3E}">
        <p14:creationId xmlns:p14="http://schemas.microsoft.com/office/powerpoint/2010/main" val="180243950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568</TotalTime>
  <Words>172</Words>
  <Application>Microsoft Office PowerPoint</Application>
  <PresentationFormat>A4 Paper (210x297 mm)</PresentationFormat>
  <Paragraphs>137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Tahoma</vt:lpstr>
      <vt:lpstr>Times New Roman</vt:lpstr>
      <vt:lpstr>Office Theme</vt:lpstr>
      <vt:lpstr>PowerPoint Presentation</vt:lpstr>
    </vt:vector>
  </TitlesOfParts>
  <Company>MPI for chemical ecology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erb</dc:creator>
  <cp:lastModifiedBy>Ricardo Machado</cp:lastModifiedBy>
  <cp:revision>156</cp:revision>
  <cp:lastPrinted>2012-12-20T15:42:23Z</cp:lastPrinted>
  <dcterms:created xsi:type="dcterms:W3CDTF">2012-11-03T11:02:56Z</dcterms:created>
  <dcterms:modified xsi:type="dcterms:W3CDTF">2016-05-02T13:44:54Z</dcterms:modified>
</cp:coreProperties>
</file>